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1052175" cy="543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B79ED5-A698-4D50-A2D1-18BA2A564051}" v="1" dt="2024-07-23T07:51:30.5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4" y="5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81522" y="889577"/>
            <a:ext cx="8289131" cy="1892394"/>
          </a:xfrm>
        </p:spPr>
        <p:txBody>
          <a:bodyPr anchor="b"/>
          <a:lstStyle>
            <a:lvl1pPr algn="ctr">
              <a:defRPr sz="4756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81522" y="2854948"/>
            <a:ext cx="8289131" cy="1312345"/>
          </a:xfrm>
        </p:spPr>
        <p:txBody>
          <a:bodyPr/>
          <a:lstStyle>
            <a:lvl1pPr marL="0" indent="0" algn="ctr">
              <a:buNone/>
              <a:defRPr sz="1902"/>
            </a:lvl1pPr>
            <a:lvl2pPr marL="362377" indent="0" algn="ctr">
              <a:buNone/>
              <a:defRPr sz="1585"/>
            </a:lvl2pPr>
            <a:lvl3pPr marL="724753" indent="0" algn="ctr">
              <a:buNone/>
              <a:defRPr sz="1427"/>
            </a:lvl3pPr>
            <a:lvl4pPr marL="1087130" indent="0" algn="ctr">
              <a:buNone/>
              <a:defRPr sz="1268"/>
            </a:lvl4pPr>
            <a:lvl5pPr marL="1449507" indent="0" algn="ctr">
              <a:buNone/>
              <a:defRPr sz="1268"/>
            </a:lvl5pPr>
            <a:lvl6pPr marL="1811884" indent="0" algn="ctr">
              <a:buNone/>
              <a:defRPr sz="1268"/>
            </a:lvl6pPr>
            <a:lvl7pPr marL="2174260" indent="0" algn="ctr">
              <a:buNone/>
              <a:defRPr sz="1268"/>
            </a:lvl7pPr>
            <a:lvl8pPr marL="2536637" indent="0" algn="ctr">
              <a:buNone/>
              <a:defRPr sz="1268"/>
            </a:lvl8pPr>
            <a:lvl9pPr marL="2899014" indent="0" algn="ctr">
              <a:buNone/>
              <a:defRPr sz="1268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92496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49268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09213" y="289395"/>
            <a:ext cx="2383125" cy="4606420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9837" y="289395"/>
            <a:ext cx="7011224" cy="4606420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1948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0904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4081" y="1355126"/>
            <a:ext cx="9532501" cy="2261058"/>
          </a:xfrm>
        </p:spPr>
        <p:txBody>
          <a:bodyPr anchor="b"/>
          <a:lstStyle>
            <a:lvl1pPr>
              <a:defRPr sz="4756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081" y="3637575"/>
            <a:ext cx="9532501" cy="1189037"/>
          </a:xfrm>
        </p:spPr>
        <p:txBody>
          <a:bodyPr/>
          <a:lstStyle>
            <a:lvl1pPr marL="0" indent="0">
              <a:buNone/>
              <a:defRPr sz="1902">
                <a:solidFill>
                  <a:schemeClr val="tx1">
                    <a:tint val="75000"/>
                  </a:schemeClr>
                </a:solidFill>
              </a:defRPr>
            </a:lvl1pPr>
            <a:lvl2pPr marL="362377" indent="0">
              <a:buNone/>
              <a:defRPr sz="1585">
                <a:solidFill>
                  <a:schemeClr val="tx1">
                    <a:tint val="75000"/>
                  </a:schemeClr>
                </a:solidFill>
              </a:defRPr>
            </a:lvl2pPr>
            <a:lvl3pPr marL="724753" indent="0">
              <a:buNone/>
              <a:defRPr sz="1427">
                <a:solidFill>
                  <a:schemeClr val="tx1">
                    <a:tint val="75000"/>
                  </a:schemeClr>
                </a:solidFill>
              </a:defRPr>
            </a:lvl3pPr>
            <a:lvl4pPr marL="1087130" indent="0">
              <a:buNone/>
              <a:defRPr sz="1268">
                <a:solidFill>
                  <a:schemeClr val="tx1">
                    <a:tint val="75000"/>
                  </a:schemeClr>
                </a:solidFill>
              </a:defRPr>
            </a:lvl4pPr>
            <a:lvl5pPr marL="1449507" indent="0">
              <a:buNone/>
              <a:defRPr sz="1268">
                <a:solidFill>
                  <a:schemeClr val="tx1">
                    <a:tint val="75000"/>
                  </a:schemeClr>
                </a:solidFill>
              </a:defRPr>
            </a:lvl5pPr>
            <a:lvl6pPr marL="1811884" indent="0">
              <a:buNone/>
              <a:defRPr sz="1268">
                <a:solidFill>
                  <a:schemeClr val="tx1">
                    <a:tint val="75000"/>
                  </a:schemeClr>
                </a:solidFill>
              </a:defRPr>
            </a:lvl6pPr>
            <a:lvl7pPr marL="2174260" indent="0">
              <a:buNone/>
              <a:defRPr sz="1268">
                <a:solidFill>
                  <a:schemeClr val="tx1">
                    <a:tint val="75000"/>
                  </a:schemeClr>
                </a:solidFill>
              </a:defRPr>
            </a:lvl7pPr>
            <a:lvl8pPr marL="2536637" indent="0">
              <a:buNone/>
              <a:defRPr sz="1268">
                <a:solidFill>
                  <a:schemeClr val="tx1">
                    <a:tint val="75000"/>
                  </a:schemeClr>
                </a:solidFill>
              </a:defRPr>
            </a:lvl8pPr>
            <a:lvl9pPr marL="2899014" indent="0">
              <a:buNone/>
              <a:defRPr sz="1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34925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9837" y="1446977"/>
            <a:ext cx="4697174" cy="34488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95164" y="1446977"/>
            <a:ext cx="4697174" cy="34488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17687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1277" y="289396"/>
            <a:ext cx="9532501" cy="1050631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1277" y="1332477"/>
            <a:ext cx="4675588" cy="653027"/>
          </a:xfrm>
        </p:spPr>
        <p:txBody>
          <a:bodyPr anchor="b"/>
          <a:lstStyle>
            <a:lvl1pPr marL="0" indent="0">
              <a:buNone/>
              <a:defRPr sz="1902" b="1"/>
            </a:lvl1pPr>
            <a:lvl2pPr marL="362377" indent="0">
              <a:buNone/>
              <a:defRPr sz="1585" b="1"/>
            </a:lvl2pPr>
            <a:lvl3pPr marL="724753" indent="0">
              <a:buNone/>
              <a:defRPr sz="1427" b="1"/>
            </a:lvl3pPr>
            <a:lvl4pPr marL="1087130" indent="0">
              <a:buNone/>
              <a:defRPr sz="1268" b="1"/>
            </a:lvl4pPr>
            <a:lvl5pPr marL="1449507" indent="0">
              <a:buNone/>
              <a:defRPr sz="1268" b="1"/>
            </a:lvl5pPr>
            <a:lvl6pPr marL="1811884" indent="0">
              <a:buNone/>
              <a:defRPr sz="1268" b="1"/>
            </a:lvl6pPr>
            <a:lvl7pPr marL="2174260" indent="0">
              <a:buNone/>
              <a:defRPr sz="1268" b="1"/>
            </a:lvl7pPr>
            <a:lvl8pPr marL="2536637" indent="0">
              <a:buNone/>
              <a:defRPr sz="1268" b="1"/>
            </a:lvl8pPr>
            <a:lvl9pPr marL="2899014" indent="0">
              <a:buNone/>
              <a:defRPr sz="1268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1277" y="1985504"/>
            <a:ext cx="4675588" cy="2920377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95164" y="1332477"/>
            <a:ext cx="4698614" cy="653027"/>
          </a:xfrm>
        </p:spPr>
        <p:txBody>
          <a:bodyPr anchor="b"/>
          <a:lstStyle>
            <a:lvl1pPr marL="0" indent="0">
              <a:buNone/>
              <a:defRPr sz="1902" b="1"/>
            </a:lvl1pPr>
            <a:lvl2pPr marL="362377" indent="0">
              <a:buNone/>
              <a:defRPr sz="1585" b="1"/>
            </a:lvl2pPr>
            <a:lvl3pPr marL="724753" indent="0">
              <a:buNone/>
              <a:defRPr sz="1427" b="1"/>
            </a:lvl3pPr>
            <a:lvl4pPr marL="1087130" indent="0">
              <a:buNone/>
              <a:defRPr sz="1268" b="1"/>
            </a:lvl4pPr>
            <a:lvl5pPr marL="1449507" indent="0">
              <a:buNone/>
              <a:defRPr sz="1268" b="1"/>
            </a:lvl5pPr>
            <a:lvl6pPr marL="1811884" indent="0">
              <a:buNone/>
              <a:defRPr sz="1268" b="1"/>
            </a:lvl6pPr>
            <a:lvl7pPr marL="2174260" indent="0">
              <a:buNone/>
              <a:defRPr sz="1268" b="1"/>
            </a:lvl7pPr>
            <a:lvl8pPr marL="2536637" indent="0">
              <a:buNone/>
              <a:defRPr sz="1268" b="1"/>
            </a:lvl8pPr>
            <a:lvl9pPr marL="2899014" indent="0">
              <a:buNone/>
              <a:defRPr sz="1268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95164" y="1985504"/>
            <a:ext cx="4698614" cy="2920377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23758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15325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19952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1277" y="362373"/>
            <a:ext cx="3564614" cy="1268307"/>
          </a:xfrm>
        </p:spPr>
        <p:txBody>
          <a:bodyPr anchor="b"/>
          <a:lstStyle>
            <a:lvl1pPr>
              <a:defRPr sz="2536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98614" y="782626"/>
            <a:ext cx="5595164" cy="3862799"/>
          </a:xfrm>
        </p:spPr>
        <p:txBody>
          <a:bodyPr/>
          <a:lstStyle>
            <a:lvl1pPr>
              <a:defRPr sz="2536"/>
            </a:lvl1pPr>
            <a:lvl2pPr>
              <a:defRPr sz="2219"/>
            </a:lvl2pPr>
            <a:lvl3pPr>
              <a:defRPr sz="1902"/>
            </a:lvl3pPr>
            <a:lvl4pPr>
              <a:defRPr sz="1585"/>
            </a:lvl4pPr>
            <a:lvl5pPr>
              <a:defRPr sz="1585"/>
            </a:lvl5pPr>
            <a:lvl6pPr>
              <a:defRPr sz="1585"/>
            </a:lvl6pPr>
            <a:lvl7pPr>
              <a:defRPr sz="1585"/>
            </a:lvl7pPr>
            <a:lvl8pPr>
              <a:defRPr sz="1585"/>
            </a:lvl8pPr>
            <a:lvl9pPr>
              <a:defRPr sz="1585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1277" y="1630680"/>
            <a:ext cx="3564614" cy="3021036"/>
          </a:xfrm>
        </p:spPr>
        <p:txBody>
          <a:bodyPr/>
          <a:lstStyle>
            <a:lvl1pPr marL="0" indent="0">
              <a:buNone/>
              <a:defRPr sz="1268"/>
            </a:lvl1pPr>
            <a:lvl2pPr marL="362377" indent="0">
              <a:buNone/>
              <a:defRPr sz="1110"/>
            </a:lvl2pPr>
            <a:lvl3pPr marL="724753" indent="0">
              <a:buNone/>
              <a:defRPr sz="951"/>
            </a:lvl3pPr>
            <a:lvl4pPr marL="1087130" indent="0">
              <a:buNone/>
              <a:defRPr sz="793"/>
            </a:lvl4pPr>
            <a:lvl5pPr marL="1449507" indent="0">
              <a:buNone/>
              <a:defRPr sz="793"/>
            </a:lvl5pPr>
            <a:lvl6pPr marL="1811884" indent="0">
              <a:buNone/>
              <a:defRPr sz="793"/>
            </a:lvl6pPr>
            <a:lvl7pPr marL="2174260" indent="0">
              <a:buNone/>
              <a:defRPr sz="793"/>
            </a:lvl7pPr>
            <a:lvl8pPr marL="2536637" indent="0">
              <a:buNone/>
              <a:defRPr sz="793"/>
            </a:lvl8pPr>
            <a:lvl9pPr marL="2899014" indent="0">
              <a:buNone/>
              <a:defRPr sz="793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81502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1277" y="362373"/>
            <a:ext cx="3564614" cy="1268307"/>
          </a:xfrm>
        </p:spPr>
        <p:txBody>
          <a:bodyPr anchor="b"/>
          <a:lstStyle>
            <a:lvl1pPr>
              <a:defRPr sz="2536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98614" y="782626"/>
            <a:ext cx="5595164" cy="3862799"/>
          </a:xfrm>
        </p:spPr>
        <p:txBody>
          <a:bodyPr anchor="t"/>
          <a:lstStyle>
            <a:lvl1pPr marL="0" indent="0">
              <a:buNone/>
              <a:defRPr sz="2536"/>
            </a:lvl1pPr>
            <a:lvl2pPr marL="362377" indent="0">
              <a:buNone/>
              <a:defRPr sz="2219"/>
            </a:lvl2pPr>
            <a:lvl3pPr marL="724753" indent="0">
              <a:buNone/>
              <a:defRPr sz="1902"/>
            </a:lvl3pPr>
            <a:lvl4pPr marL="1087130" indent="0">
              <a:buNone/>
              <a:defRPr sz="1585"/>
            </a:lvl4pPr>
            <a:lvl5pPr marL="1449507" indent="0">
              <a:buNone/>
              <a:defRPr sz="1585"/>
            </a:lvl5pPr>
            <a:lvl6pPr marL="1811884" indent="0">
              <a:buNone/>
              <a:defRPr sz="1585"/>
            </a:lvl6pPr>
            <a:lvl7pPr marL="2174260" indent="0">
              <a:buNone/>
              <a:defRPr sz="1585"/>
            </a:lvl7pPr>
            <a:lvl8pPr marL="2536637" indent="0">
              <a:buNone/>
              <a:defRPr sz="1585"/>
            </a:lvl8pPr>
            <a:lvl9pPr marL="2899014" indent="0">
              <a:buNone/>
              <a:defRPr sz="1585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1277" y="1630680"/>
            <a:ext cx="3564614" cy="3021036"/>
          </a:xfrm>
        </p:spPr>
        <p:txBody>
          <a:bodyPr/>
          <a:lstStyle>
            <a:lvl1pPr marL="0" indent="0">
              <a:buNone/>
              <a:defRPr sz="1268"/>
            </a:lvl1pPr>
            <a:lvl2pPr marL="362377" indent="0">
              <a:buNone/>
              <a:defRPr sz="1110"/>
            </a:lvl2pPr>
            <a:lvl3pPr marL="724753" indent="0">
              <a:buNone/>
              <a:defRPr sz="951"/>
            </a:lvl3pPr>
            <a:lvl4pPr marL="1087130" indent="0">
              <a:buNone/>
              <a:defRPr sz="793"/>
            </a:lvl4pPr>
            <a:lvl5pPr marL="1449507" indent="0">
              <a:buNone/>
              <a:defRPr sz="793"/>
            </a:lvl5pPr>
            <a:lvl6pPr marL="1811884" indent="0">
              <a:buNone/>
              <a:defRPr sz="793"/>
            </a:lvl6pPr>
            <a:lvl7pPr marL="2174260" indent="0">
              <a:buNone/>
              <a:defRPr sz="793"/>
            </a:lvl7pPr>
            <a:lvl8pPr marL="2536637" indent="0">
              <a:buNone/>
              <a:defRPr sz="793"/>
            </a:lvl8pPr>
            <a:lvl9pPr marL="2899014" indent="0">
              <a:buNone/>
              <a:defRPr sz="793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60292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9837" y="289396"/>
            <a:ext cx="9532501" cy="10506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9837" y="1446977"/>
            <a:ext cx="9532501" cy="3448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9837" y="5037997"/>
            <a:ext cx="2486739" cy="289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FD444-54D6-46BF-AE07-87FECB0A6AC7}" type="datetimeFigureOut">
              <a:rPr lang="nl-NL" smtClean="0"/>
              <a:t>23-7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61033" y="5037997"/>
            <a:ext cx="3730109" cy="289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05599" y="5037997"/>
            <a:ext cx="2486739" cy="289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5CE0E-A6F7-404E-A9CE-818A81C3579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20566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4753" rtl="0" eaLnBrk="1" latinLnBrk="0" hangingPunct="1">
        <a:lnSpc>
          <a:spcPct val="90000"/>
        </a:lnSpc>
        <a:spcBef>
          <a:spcPct val="0"/>
        </a:spcBef>
        <a:buNone/>
        <a:defRPr sz="34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1188" indent="-181188" algn="l" defTabSz="724753" rtl="0" eaLnBrk="1" latinLnBrk="0" hangingPunct="1">
        <a:lnSpc>
          <a:spcPct val="90000"/>
        </a:lnSpc>
        <a:spcBef>
          <a:spcPts val="793"/>
        </a:spcBef>
        <a:buFont typeface="Arial" panose="020B0604020202020204" pitchFamily="34" charset="0"/>
        <a:buChar char="•"/>
        <a:defRPr sz="2219" kern="1200">
          <a:solidFill>
            <a:schemeClr val="tx1"/>
          </a:solidFill>
          <a:latin typeface="+mn-lt"/>
          <a:ea typeface="+mn-ea"/>
          <a:cs typeface="+mn-cs"/>
        </a:defRPr>
      </a:lvl1pPr>
      <a:lvl2pPr marL="543565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902" kern="1200">
          <a:solidFill>
            <a:schemeClr val="tx1"/>
          </a:solidFill>
          <a:latin typeface="+mn-lt"/>
          <a:ea typeface="+mn-ea"/>
          <a:cs typeface="+mn-cs"/>
        </a:defRPr>
      </a:lvl2pPr>
      <a:lvl3pPr marL="905942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585" kern="1200">
          <a:solidFill>
            <a:schemeClr val="tx1"/>
          </a:solidFill>
          <a:latin typeface="+mn-lt"/>
          <a:ea typeface="+mn-ea"/>
          <a:cs typeface="+mn-cs"/>
        </a:defRPr>
      </a:lvl3pPr>
      <a:lvl4pPr marL="1268319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7" kern="1200">
          <a:solidFill>
            <a:schemeClr val="tx1"/>
          </a:solidFill>
          <a:latin typeface="+mn-lt"/>
          <a:ea typeface="+mn-ea"/>
          <a:cs typeface="+mn-cs"/>
        </a:defRPr>
      </a:lvl4pPr>
      <a:lvl5pPr marL="1630695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7" kern="1200">
          <a:solidFill>
            <a:schemeClr val="tx1"/>
          </a:solidFill>
          <a:latin typeface="+mn-lt"/>
          <a:ea typeface="+mn-ea"/>
          <a:cs typeface="+mn-cs"/>
        </a:defRPr>
      </a:lvl5pPr>
      <a:lvl6pPr marL="1993072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7" kern="1200">
          <a:solidFill>
            <a:schemeClr val="tx1"/>
          </a:solidFill>
          <a:latin typeface="+mn-lt"/>
          <a:ea typeface="+mn-ea"/>
          <a:cs typeface="+mn-cs"/>
        </a:defRPr>
      </a:lvl6pPr>
      <a:lvl7pPr marL="2355449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7" kern="1200">
          <a:solidFill>
            <a:schemeClr val="tx1"/>
          </a:solidFill>
          <a:latin typeface="+mn-lt"/>
          <a:ea typeface="+mn-ea"/>
          <a:cs typeface="+mn-cs"/>
        </a:defRPr>
      </a:lvl7pPr>
      <a:lvl8pPr marL="2717825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7" kern="1200">
          <a:solidFill>
            <a:schemeClr val="tx1"/>
          </a:solidFill>
          <a:latin typeface="+mn-lt"/>
          <a:ea typeface="+mn-ea"/>
          <a:cs typeface="+mn-cs"/>
        </a:defRPr>
      </a:lvl8pPr>
      <a:lvl9pPr marL="3080202" indent="-181188" algn="l" defTabSz="724753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1pPr>
      <a:lvl2pPr marL="362377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2pPr>
      <a:lvl3pPr marL="724753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3pPr>
      <a:lvl4pPr marL="1087130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4pPr>
      <a:lvl5pPr marL="1449507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5pPr>
      <a:lvl6pPr marL="1811884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6pPr>
      <a:lvl7pPr marL="2174260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7pPr>
      <a:lvl8pPr marL="2536637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8pPr>
      <a:lvl9pPr marL="2899014" algn="l" defTabSz="724753" rtl="0" eaLnBrk="1" latinLnBrk="0" hangingPunct="1">
        <a:defRPr sz="142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Rechthoek 63">
            <a:extLst>
              <a:ext uri="{FF2B5EF4-FFF2-40B4-BE49-F238E27FC236}">
                <a16:creationId xmlns:a16="http://schemas.microsoft.com/office/drawing/2014/main" id="{AEB2D7EE-661A-39C9-25CF-F1A411F180AC}"/>
              </a:ext>
            </a:extLst>
          </p:cNvPr>
          <p:cNvSpPr/>
          <p:nvPr/>
        </p:nvSpPr>
        <p:spPr>
          <a:xfrm>
            <a:off x="4018797" y="1132702"/>
            <a:ext cx="2971088" cy="43088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nl-NL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. I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proving the employer's actions in accordance with guided legislation and protocols</a:t>
            </a:r>
            <a:endParaRPr lang="nl-NL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5" name="Rechthoek 64">
            <a:extLst>
              <a:ext uri="{FF2B5EF4-FFF2-40B4-BE49-F238E27FC236}">
                <a16:creationId xmlns:a16="http://schemas.microsoft.com/office/drawing/2014/main" id="{38EFA380-EFD5-86CD-DB44-61DC1CB30E8C}"/>
              </a:ext>
            </a:extLst>
          </p:cNvPr>
          <p:cNvSpPr/>
          <p:nvPr/>
        </p:nvSpPr>
        <p:spPr>
          <a:xfrm>
            <a:off x="4018797" y="1647745"/>
            <a:ext cx="2971087" cy="615553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nl-NL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roving communication (including emotional support) from the employer with employees on sick leave</a:t>
            </a:r>
            <a:endParaRPr lang="nl-NL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6" name="Rechthoek 65">
            <a:extLst>
              <a:ext uri="{FF2B5EF4-FFF2-40B4-BE49-F238E27FC236}">
                <a16:creationId xmlns:a16="http://schemas.microsoft.com/office/drawing/2014/main" id="{C0466D22-F85E-D61A-FB35-5DF7B0F91152}"/>
              </a:ext>
            </a:extLst>
          </p:cNvPr>
          <p:cNvSpPr/>
          <p:nvPr/>
        </p:nvSpPr>
        <p:spPr>
          <a:xfrm>
            <a:off x="2547228" y="1571460"/>
            <a:ext cx="1024092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nl-NL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utonomy</a:t>
            </a:r>
            <a:endParaRPr lang="nl-NL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7" name="Rechthoek 66">
            <a:extLst>
              <a:ext uri="{FF2B5EF4-FFF2-40B4-BE49-F238E27FC236}">
                <a16:creationId xmlns:a16="http://schemas.microsoft.com/office/drawing/2014/main" id="{48200833-EB07-7DFE-FFF0-E3D366D5679A}"/>
              </a:ext>
            </a:extLst>
          </p:cNvPr>
          <p:cNvSpPr/>
          <p:nvPr/>
        </p:nvSpPr>
        <p:spPr>
          <a:xfrm>
            <a:off x="2564702" y="2459978"/>
            <a:ext cx="1024092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nl-NL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etence</a:t>
            </a:r>
            <a:endParaRPr lang="nl-NL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8" name="Rechthoek 67">
            <a:extLst>
              <a:ext uri="{FF2B5EF4-FFF2-40B4-BE49-F238E27FC236}">
                <a16:creationId xmlns:a16="http://schemas.microsoft.com/office/drawing/2014/main" id="{3363B958-4EA2-DCF1-A0D0-07ACBC3CE7C5}"/>
              </a:ext>
            </a:extLst>
          </p:cNvPr>
          <p:cNvSpPr/>
          <p:nvPr/>
        </p:nvSpPr>
        <p:spPr>
          <a:xfrm>
            <a:off x="2547228" y="3461070"/>
            <a:ext cx="1024092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nl-NL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edness</a:t>
            </a:r>
            <a:endParaRPr lang="nl-NL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9" name="Rechteraccolade 68">
            <a:extLst>
              <a:ext uri="{FF2B5EF4-FFF2-40B4-BE49-F238E27FC236}">
                <a16:creationId xmlns:a16="http://schemas.microsoft.com/office/drawing/2014/main" id="{A48163AE-31FA-8E77-DDC3-F3F5C3B6D642}"/>
              </a:ext>
            </a:extLst>
          </p:cNvPr>
          <p:cNvSpPr/>
          <p:nvPr/>
        </p:nvSpPr>
        <p:spPr>
          <a:xfrm>
            <a:off x="3573816" y="1694570"/>
            <a:ext cx="347553" cy="1909160"/>
          </a:xfrm>
          <a:prstGeom prst="rightBrace">
            <a:avLst>
              <a:gd name="adj1" fmla="val 44830"/>
              <a:gd name="adj2" fmla="val 45292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 sz="2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hteraccolade 69">
            <a:extLst>
              <a:ext uri="{FF2B5EF4-FFF2-40B4-BE49-F238E27FC236}">
                <a16:creationId xmlns:a16="http://schemas.microsoft.com/office/drawing/2014/main" id="{2D95F171-0D21-163E-8DAE-26B0A56D7DE5}"/>
              </a:ext>
            </a:extLst>
          </p:cNvPr>
          <p:cNvSpPr/>
          <p:nvPr/>
        </p:nvSpPr>
        <p:spPr>
          <a:xfrm>
            <a:off x="6989884" y="1303935"/>
            <a:ext cx="598508" cy="3239889"/>
          </a:xfrm>
          <a:prstGeom prst="rightBrace">
            <a:avLst>
              <a:gd name="adj1" fmla="val 44830"/>
              <a:gd name="adj2" fmla="val 46591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 sz="2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Rechte verbindingslijn met pijl 70">
            <a:extLst>
              <a:ext uri="{FF2B5EF4-FFF2-40B4-BE49-F238E27FC236}">
                <a16:creationId xmlns:a16="http://schemas.microsoft.com/office/drawing/2014/main" id="{5789F072-0092-A00F-A0C1-E5AA5ED7A9FF}"/>
              </a:ext>
            </a:extLst>
          </p:cNvPr>
          <p:cNvCxnSpPr>
            <a:stCxn id="70" idx="1"/>
            <a:endCxn id="79" idx="1"/>
          </p:cNvCxnSpPr>
          <p:nvPr/>
        </p:nvCxnSpPr>
        <p:spPr>
          <a:xfrm flipV="1">
            <a:off x="7588392" y="2811127"/>
            <a:ext cx="245301" cy="23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Rechthoek 71">
            <a:extLst>
              <a:ext uri="{FF2B5EF4-FFF2-40B4-BE49-F238E27FC236}">
                <a16:creationId xmlns:a16="http://schemas.microsoft.com/office/drawing/2014/main" id="{3503A579-D3DD-92A1-90F6-A8871F405222}"/>
              </a:ext>
            </a:extLst>
          </p:cNvPr>
          <p:cNvSpPr/>
          <p:nvPr/>
        </p:nvSpPr>
        <p:spPr>
          <a:xfrm>
            <a:off x="419723" y="1114918"/>
            <a:ext cx="1688299" cy="1015663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employer is capable of acting in line with their organizational values and experiences freedom in doing so</a:t>
            </a:r>
          </a:p>
        </p:txBody>
      </p:sp>
      <p:sp>
        <p:nvSpPr>
          <p:cNvPr id="73" name="Rechthoek 72">
            <a:extLst>
              <a:ext uri="{FF2B5EF4-FFF2-40B4-BE49-F238E27FC236}">
                <a16:creationId xmlns:a16="http://schemas.microsoft.com/office/drawing/2014/main" id="{FA4CC118-CBAE-310A-AC6C-0445767EF2BB}"/>
              </a:ext>
            </a:extLst>
          </p:cNvPr>
          <p:cNvSpPr/>
          <p:nvPr/>
        </p:nvSpPr>
        <p:spPr>
          <a:xfrm>
            <a:off x="4010526" y="2345297"/>
            <a:ext cx="2979358" cy="43088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nl-NL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proactive involvement of the right stakeholders by the employer</a:t>
            </a:r>
            <a:endParaRPr lang="nl-NL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4" name="Rechthoek 73">
            <a:extLst>
              <a:ext uri="{FF2B5EF4-FFF2-40B4-BE49-F238E27FC236}">
                <a16:creationId xmlns:a16="http://schemas.microsoft.com/office/drawing/2014/main" id="{DA2317AC-F135-348B-79AF-E27AF631246B}"/>
              </a:ext>
            </a:extLst>
          </p:cNvPr>
          <p:cNvSpPr/>
          <p:nvPr/>
        </p:nvSpPr>
        <p:spPr>
          <a:xfrm>
            <a:off x="4030364" y="2874478"/>
            <a:ext cx="2959520" cy="26161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nl-NL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. Improvement of practical support</a:t>
            </a:r>
          </a:p>
        </p:txBody>
      </p:sp>
      <p:sp>
        <p:nvSpPr>
          <p:cNvPr id="75" name="Rechthoek 74">
            <a:extLst>
              <a:ext uri="{FF2B5EF4-FFF2-40B4-BE49-F238E27FC236}">
                <a16:creationId xmlns:a16="http://schemas.microsoft.com/office/drawing/2014/main" id="{FAACDE86-C7EC-A25D-F419-3C4F648A1DDC}"/>
              </a:ext>
            </a:extLst>
          </p:cNvPr>
          <p:cNvSpPr/>
          <p:nvPr/>
        </p:nvSpPr>
        <p:spPr>
          <a:xfrm>
            <a:off x="4030364" y="3223242"/>
            <a:ext cx="2959520" cy="43088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nl-NL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suring the right timing, conditions, and actions by the employer during return to work</a:t>
            </a:r>
            <a:endParaRPr lang="nl-NL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6" name="Rechthoek 75">
            <a:extLst>
              <a:ext uri="{FF2B5EF4-FFF2-40B4-BE49-F238E27FC236}">
                <a16:creationId xmlns:a16="http://schemas.microsoft.com/office/drawing/2014/main" id="{06183D5C-6F05-2B9D-69CB-EC669026909A}"/>
              </a:ext>
            </a:extLst>
          </p:cNvPr>
          <p:cNvSpPr/>
          <p:nvPr/>
        </p:nvSpPr>
        <p:spPr>
          <a:xfrm>
            <a:off x="4020445" y="3740224"/>
            <a:ext cx="2959520" cy="43088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nl-NL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roving employer actions aimed at preventing relapse after return to work</a:t>
            </a:r>
            <a:endParaRPr lang="nl-NL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7" name="Rechthoek 76">
            <a:extLst>
              <a:ext uri="{FF2B5EF4-FFF2-40B4-BE49-F238E27FC236}">
                <a16:creationId xmlns:a16="http://schemas.microsoft.com/office/drawing/2014/main" id="{32A41F85-952A-50B8-95AC-2F6CD5DCD5EA}"/>
              </a:ext>
            </a:extLst>
          </p:cNvPr>
          <p:cNvSpPr/>
          <p:nvPr/>
        </p:nvSpPr>
        <p:spPr>
          <a:xfrm>
            <a:off x="4030364" y="4274996"/>
            <a:ext cx="2959520" cy="43088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nl-NL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suring an employer's plan/ policy/ measures to prevent possible new absenteeism</a:t>
            </a:r>
            <a:endParaRPr lang="nl-NL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8" name="Rechthoek 77">
            <a:extLst>
              <a:ext uri="{FF2B5EF4-FFF2-40B4-BE49-F238E27FC236}">
                <a16:creationId xmlns:a16="http://schemas.microsoft.com/office/drawing/2014/main" id="{8CE28EAC-8292-8322-CFA2-04C1B0743D95}"/>
              </a:ext>
            </a:extLst>
          </p:cNvPr>
          <p:cNvSpPr/>
          <p:nvPr/>
        </p:nvSpPr>
        <p:spPr>
          <a:xfrm>
            <a:off x="9318049" y="2395628"/>
            <a:ext cx="1338858" cy="83099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tisfaction of employee with the return to work guidance </a:t>
            </a:r>
            <a:r>
              <a:rPr lang="nl-NL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↑ </a:t>
            </a:r>
          </a:p>
        </p:txBody>
      </p:sp>
      <p:sp>
        <p:nvSpPr>
          <p:cNvPr id="79" name="Rechthoek 78">
            <a:extLst>
              <a:ext uri="{FF2B5EF4-FFF2-40B4-BE49-F238E27FC236}">
                <a16:creationId xmlns:a16="http://schemas.microsoft.com/office/drawing/2014/main" id="{35E4AF62-68F6-00B9-7535-25672B6AC602}"/>
              </a:ext>
            </a:extLst>
          </p:cNvPr>
          <p:cNvSpPr/>
          <p:nvPr/>
        </p:nvSpPr>
        <p:spPr>
          <a:xfrm>
            <a:off x="7833693" y="2580294"/>
            <a:ext cx="1221179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nl-NL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cial support of employer ↑ </a:t>
            </a:r>
            <a:endParaRPr lang="nl-NL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80" name="Rechte verbindingslijn met pijl 79">
            <a:extLst>
              <a:ext uri="{FF2B5EF4-FFF2-40B4-BE49-F238E27FC236}">
                <a16:creationId xmlns:a16="http://schemas.microsoft.com/office/drawing/2014/main" id="{DEEF63D5-418A-12E6-AEBE-A4B612FA5F7C}"/>
              </a:ext>
            </a:extLst>
          </p:cNvPr>
          <p:cNvCxnSpPr>
            <a:stCxn id="79" idx="3"/>
            <a:endCxn id="78" idx="1"/>
          </p:cNvCxnSpPr>
          <p:nvPr/>
        </p:nvCxnSpPr>
        <p:spPr>
          <a:xfrm>
            <a:off x="9054872" y="2811127"/>
            <a:ext cx="2631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Rechthoek 80">
            <a:extLst>
              <a:ext uri="{FF2B5EF4-FFF2-40B4-BE49-F238E27FC236}">
                <a16:creationId xmlns:a16="http://schemas.microsoft.com/office/drawing/2014/main" id="{3AEC8C79-7628-1CB3-3F3B-D383901AC72D}"/>
              </a:ext>
            </a:extLst>
          </p:cNvPr>
          <p:cNvSpPr/>
          <p:nvPr/>
        </p:nvSpPr>
        <p:spPr>
          <a:xfrm>
            <a:off x="275446" y="673371"/>
            <a:ext cx="10493998" cy="276999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echthoek 81">
            <a:extLst>
              <a:ext uri="{FF2B5EF4-FFF2-40B4-BE49-F238E27FC236}">
                <a16:creationId xmlns:a16="http://schemas.microsoft.com/office/drawing/2014/main" id="{73D082B4-D412-D646-9B23-B4293A7651C7}"/>
              </a:ext>
            </a:extLst>
          </p:cNvPr>
          <p:cNvSpPr/>
          <p:nvPr/>
        </p:nvSpPr>
        <p:spPr>
          <a:xfrm>
            <a:off x="348493" y="673371"/>
            <a:ext cx="19559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ample change objectives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hthoek 82">
            <a:extLst>
              <a:ext uri="{FF2B5EF4-FFF2-40B4-BE49-F238E27FC236}">
                <a16:creationId xmlns:a16="http://schemas.microsoft.com/office/drawing/2014/main" id="{1D989FAD-4BF4-3113-391E-41E85060801E}"/>
              </a:ext>
            </a:extLst>
          </p:cNvPr>
          <p:cNvSpPr/>
          <p:nvPr/>
        </p:nvSpPr>
        <p:spPr>
          <a:xfrm>
            <a:off x="2564669" y="664578"/>
            <a:ext cx="10823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terminants</a:t>
            </a:r>
            <a:endParaRPr lang="nl-N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Rechthoek 83">
            <a:extLst>
              <a:ext uri="{FF2B5EF4-FFF2-40B4-BE49-F238E27FC236}">
                <a16:creationId xmlns:a16="http://schemas.microsoft.com/office/drawing/2014/main" id="{B4A212F5-A5B3-DC79-C3F3-748080A655BD}"/>
              </a:ext>
            </a:extLst>
          </p:cNvPr>
          <p:cNvSpPr/>
          <p:nvPr/>
        </p:nvSpPr>
        <p:spPr>
          <a:xfrm>
            <a:off x="4657275" y="673373"/>
            <a:ext cx="173156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formance objectives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Rechthoek 84">
            <a:extLst>
              <a:ext uri="{FF2B5EF4-FFF2-40B4-BE49-F238E27FC236}">
                <a16:creationId xmlns:a16="http://schemas.microsoft.com/office/drawing/2014/main" id="{6B7C3B44-B376-A908-645D-8D39B182BD64}"/>
              </a:ext>
            </a:extLst>
          </p:cNvPr>
          <p:cNvSpPr/>
          <p:nvPr/>
        </p:nvSpPr>
        <p:spPr>
          <a:xfrm>
            <a:off x="9130426" y="673371"/>
            <a:ext cx="16518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erarching objective</a:t>
            </a:r>
            <a:endParaRPr lang="nl-N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hthoek 85">
            <a:extLst>
              <a:ext uri="{FF2B5EF4-FFF2-40B4-BE49-F238E27FC236}">
                <a16:creationId xmlns:a16="http://schemas.microsoft.com/office/drawing/2014/main" id="{296AEA6F-9DAE-0A65-7777-9E163645E954}"/>
              </a:ext>
            </a:extLst>
          </p:cNvPr>
          <p:cNvSpPr/>
          <p:nvPr/>
        </p:nvSpPr>
        <p:spPr>
          <a:xfrm>
            <a:off x="7964942" y="660219"/>
            <a:ext cx="8435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utcomes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hthoek 86">
            <a:extLst>
              <a:ext uri="{FF2B5EF4-FFF2-40B4-BE49-F238E27FC236}">
                <a16:creationId xmlns:a16="http://schemas.microsoft.com/office/drawing/2014/main" id="{66AACCF8-ACD0-FD28-E425-EAA5D6A29930}"/>
              </a:ext>
            </a:extLst>
          </p:cNvPr>
          <p:cNvSpPr/>
          <p:nvPr/>
        </p:nvSpPr>
        <p:spPr>
          <a:xfrm>
            <a:off x="2564669" y="4405324"/>
            <a:ext cx="1006651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nl-NL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lity</a:t>
            </a:r>
            <a:endParaRPr lang="nl-NL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8" name="Rechthoek 87">
            <a:extLst>
              <a:ext uri="{FF2B5EF4-FFF2-40B4-BE49-F238E27FC236}">
                <a16:creationId xmlns:a16="http://schemas.microsoft.com/office/drawing/2014/main" id="{D3C82DCB-7150-5E38-F6F1-B99A7C6386C5}"/>
              </a:ext>
            </a:extLst>
          </p:cNvPr>
          <p:cNvSpPr/>
          <p:nvPr/>
        </p:nvSpPr>
        <p:spPr>
          <a:xfrm>
            <a:off x="432693" y="2360095"/>
            <a:ext cx="1675329" cy="64633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employer has knowledge of relevant legislation</a:t>
            </a:r>
          </a:p>
        </p:txBody>
      </p:sp>
      <p:sp>
        <p:nvSpPr>
          <p:cNvPr id="89" name="Rechthoek 88">
            <a:extLst>
              <a:ext uri="{FF2B5EF4-FFF2-40B4-BE49-F238E27FC236}">
                <a16:creationId xmlns:a16="http://schemas.microsoft.com/office/drawing/2014/main" id="{23FA3B8A-8F90-2008-00FB-837360A639DB}"/>
              </a:ext>
            </a:extLst>
          </p:cNvPr>
          <p:cNvSpPr/>
          <p:nvPr/>
        </p:nvSpPr>
        <p:spPr>
          <a:xfrm>
            <a:off x="432693" y="3217833"/>
            <a:ext cx="1675329" cy="1015663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employer seeks good support for employees and coordinates this with colleagues</a:t>
            </a:r>
            <a:endParaRPr lang="nl-NL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90" name="Rechte verbindingslijn met pijl 89">
            <a:extLst>
              <a:ext uri="{FF2B5EF4-FFF2-40B4-BE49-F238E27FC236}">
                <a16:creationId xmlns:a16="http://schemas.microsoft.com/office/drawing/2014/main" id="{93DDBA0F-8B8F-DAF1-27BE-608AAD88DB70}"/>
              </a:ext>
            </a:extLst>
          </p:cNvPr>
          <p:cNvCxnSpPr>
            <a:endCxn id="66" idx="1"/>
          </p:cNvCxnSpPr>
          <p:nvPr/>
        </p:nvCxnSpPr>
        <p:spPr>
          <a:xfrm>
            <a:off x="2107825" y="1707397"/>
            <a:ext cx="439403" cy="2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Rechte verbindingslijn met pijl 90">
            <a:extLst>
              <a:ext uri="{FF2B5EF4-FFF2-40B4-BE49-F238E27FC236}">
                <a16:creationId xmlns:a16="http://schemas.microsoft.com/office/drawing/2014/main" id="{84AAB396-15E0-68EF-249D-B29295B8FB7A}"/>
              </a:ext>
            </a:extLst>
          </p:cNvPr>
          <p:cNvCxnSpPr>
            <a:cxnSpLocks/>
            <a:endCxn id="67" idx="1"/>
          </p:cNvCxnSpPr>
          <p:nvPr/>
        </p:nvCxnSpPr>
        <p:spPr>
          <a:xfrm flipV="1">
            <a:off x="2098062" y="2598478"/>
            <a:ext cx="466640" cy="17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Rechte verbindingslijn met pijl 91">
            <a:extLst>
              <a:ext uri="{FF2B5EF4-FFF2-40B4-BE49-F238E27FC236}">
                <a16:creationId xmlns:a16="http://schemas.microsoft.com/office/drawing/2014/main" id="{E494C9F3-0E4E-1981-80FA-F8C685E4399C}"/>
              </a:ext>
            </a:extLst>
          </p:cNvPr>
          <p:cNvCxnSpPr/>
          <p:nvPr/>
        </p:nvCxnSpPr>
        <p:spPr>
          <a:xfrm>
            <a:off x="2098062" y="3594360"/>
            <a:ext cx="439403" cy="25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Gekromde verbindingslijn 20">
            <a:extLst>
              <a:ext uri="{FF2B5EF4-FFF2-40B4-BE49-F238E27FC236}">
                <a16:creationId xmlns:a16="http://schemas.microsoft.com/office/drawing/2014/main" id="{70F5D551-DD3D-05CC-FF9C-458191D49D44}"/>
              </a:ext>
            </a:extLst>
          </p:cNvPr>
          <p:cNvCxnSpPr>
            <a:cxnSpLocks/>
            <a:stCxn id="87" idx="3"/>
            <a:endCxn id="69" idx="1"/>
          </p:cNvCxnSpPr>
          <p:nvPr/>
        </p:nvCxnSpPr>
        <p:spPr>
          <a:xfrm flipV="1">
            <a:off x="3571320" y="2559267"/>
            <a:ext cx="350049" cy="1984557"/>
          </a:xfrm>
          <a:prstGeom prst="curvedConnector3">
            <a:avLst>
              <a:gd name="adj1" fmla="val 81155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4429816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160</Words>
  <Application>Microsoft Office PowerPoint</Application>
  <PresentationFormat>Aangepast</PresentationFormat>
  <Paragraphs>21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Kantoorth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eerda, D.C.E. (Donna)</dc:creator>
  <cp:lastModifiedBy>Beerda, D.C.E. (Donna)</cp:lastModifiedBy>
  <cp:revision>2</cp:revision>
  <dcterms:created xsi:type="dcterms:W3CDTF">2024-03-22T11:52:48Z</dcterms:created>
  <dcterms:modified xsi:type="dcterms:W3CDTF">2024-07-23T07:51:58Z</dcterms:modified>
</cp:coreProperties>
</file>